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7298DA-4F9D-FAB2-55BD-C269AC24484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665E7CA-9FFA-51F4-B1C5-7214D878ABC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2F958F-B6D1-9A72-E9BA-9E9B5B9934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C9A2D0-29B0-5F3A-486A-02CCCD1492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23E381-EB1E-8E1F-FAB5-3ECC6A8EB1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653124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B808E3-A445-6A11-4982-806D4762CB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56A17FA-3F31-FEF1-E659-2FC177F388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05B808-7EE6-79D1-4EC6-48CB7E36C8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BFB91E-9783-71B5-5334-D92E19A064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14E817-30B4-520C-1690-086E8F360C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108976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CA0F1D4-5775-1B04-CFFC-C7F2950BA21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76BDC13-DC96-76A1-BA85-92774A4492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8E3F4A-5D4A-82F6-B088-76774B1268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982726-B54D-C789-9EB6-315260C153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61A568-59BC-DE07-B3CA-DF0329F21D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034164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A930CB-4AE0-032A-5692-D81CA12F27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4A7FABA-8B01-B134-9CF9-4E26B88286B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3D0B9D-3798-7D50-9702-AAEA4AC750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55ADFA-856E-E343-89AC-7D88E015E3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23788B-D56B-0304-8079-8D1AB6C5E6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01077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639C7D-F2D6-A4E0-A0D8-5830611112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4BB438E-7CEF-E9C3-60D9-B9D0999CD4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AF4D46-8B70-35E8-07AB-DC394C35AA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7C3931-F308-55A0-1B60-0AD15111DC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845DCF-EFA4-37E3-991F-0159E67C72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347368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741EBB-D829-0E9D-8A37-888BBB2007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3CC76F3-0F10-5DFA-B62C-939F1BD20B1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9333A63-9B12-2DEB-2CE1-1AE3547EADB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79F5DEF-57A7-FA35-0DE6-487FB35141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FA21536-D74D-842D-621A-5DD1AF3FB1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EE2F49F-45E9-DA7D-E967-A5E00E62E9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7254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3EFBBF-F17F-12F4-E4C1-088DE060A2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C752EF-2A68-01E3-61A8-94BA0FEBD9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B877A6D-E365-ADAC-1A07-B82768F68D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73654B6-6CFE-61B2-3A16-AD648BBBC5A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615FC14-2C18-1DD9-9060-5FB267AF9F6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F1FB786-0028-A983-B6CE-5EE067E5DF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E0582CD-B2E0-CBFC-BBE2-19EA86655D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5B00D54-0235-9CF2-1A29-9FD01E7F0A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38413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6369CD-4D23-8BFC-A542-2B92D890B2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DD21CBA-51F0-88AD-F604-832CE87D0F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ECD55CA-98E7-46CF-7AB4-AFABA09731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22784CE-83CC-2EAC-9FEB-ACC3B17B79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001370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4040D52-7C1E-AB1D-798F-8BAE652C98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7FFA8C7-33F2-02E5-7D2A-C0D1D77228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E02132B-E01A-6E46-F0F2-9273B9525F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89271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1D4B46-A811-C07C-A508-0DF86A2E81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64E3D39-C1C6-B4B2-94B5-E3AD251DAB4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25304D2-5DEA-1878-EA86-1275E25F19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FE57E76-31E0-7F8D-E1F8-C0DAF968E4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DD6A111-82FD-9CDC-74BA-FBE7EE29F6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E1F2276-3ABC-51F8-BAED-E0F6F46D18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234590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B8B00F-6894-5048-42F0-6537E501A7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18E7382-68F0-8ADD-E54A-F075972BDA8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F7FB87C-D120-E599-35B8-DC76CD23953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5E7358D-B640-B4AE-D58C-6E698B0706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829F8AA-1B45-7650-EE90-858F206DB6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EB9F684-B59A-4A16-4297-6850B3B0A1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244822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0F27173-DD36-2C49-9885-E5F44228A6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93987A0-A5C9-B390-BE4B-D4F17764E4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9FF9C0-7219-1D1E-A1D4-A43C84BD675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DE0F85-0C1B-BA21-BF4A-39B26F1240D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91B6E6-E829-B6B3-FBEE-083D5C9CC2A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990292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4599FD3A-B089-8343-992D-8731BD8BDAB9}"/>
              </a:ext>
            </a:extLst>
          </p:cNvPr>
          <p:cNvGrpSpPr/>
          <p:nvPr/>
        </p:nvGrpSpPr>
        <p:grpSpPr>
          <a:xfrm>
            <a:off x="1322776" y="1504238"/>
            <a:ext cx="10291292" cy="3162765"/>
            <a:chOff x="1322776" y="1504238"/>
            <a:chExt cx="9546448" cy="2673315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38502002-2F71-F5CB-0AFD-1D62199218B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10800000">
              <a:off x="1322776" y="1504238"/>
              <a:ext cx="9546448" cy="2673315"/>
            </a:xfrm>
            <a:prstGeom prst="rect">
              <a:avLst/>
            </a:prstGeom>
          </p:spPr>
        </p:pic>
        <p:cxnSp>
          <p:nvCxnSpPr>
            <p:cNvPr id="7" name="Straight Arrow Connector 6">
              <a:extLst>
                <a:ext uri="{FF2B5EF4-FFF2-40B4-BE49-F238E27FC236}">
                  <a16:creationId xmlns:a16="http://schemas.microsoft.com/office/drawing/2014/main" id="{81908067-6404-E08D-4C87-65B5587486D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701478" y="1951356"/>
              <a:ext cx="499074" cy="213171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48B85DEA-90AF-AF31-8B3F-40AC1BACC9FC}"/>
                </a:ext>
              </a:extLst>
            </p:cNvPr>
            <p:cNvSpPr txBox="1"/>
            <p:nvPr/>
          </p:nvSpPr>
          <p:spPr>
            <a:xfrm>
              <a:off x="2170810" y="1549378"/>
              <a:ext cx="1528763" cy="44225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AU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Proximal Balloon Fibre Port </a:t>
              </a:r>
            </a:p>
          </p:txBody>
        </p:sp>
        <p:cxnSp>
          <p:nvCxnSpPr>
            <p:cNvPr id="9" name="Straight Arrow Connector 8">
              <a:extLst>
                <a:ext uri="{FF2B5EF4-FFF2-40B4-BE49-F238E27FC236}">
                  <a16:creationId xmlns:a16="http://schemas.microsoft.com/office/drawing/2014/main" id="{38933EDA-774B-59C6-4A9D-504D8C85F1D0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6980284" y="2591014"/>
              <a:ext cx="487265" cy="720358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38A6186A-7AE6-331F-430C-0A216F7A0EE6}"/>
                </a:ext>
              </a:extLst>
            </p:cNvPr>
            <p:cNvSpPr txBox="1"/>
            <p:nvPr/>
          </p:nvSpPr>
          <p:spPr>
            <a:xfrm>
              <a:off x="7291124" y="3311372"/>
              <a:ext cx="1528763" cy="2601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AU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GW</a:t>
              </a:r>
            </a:p>
          </p:txBody>
        </p:sp>
        <p:cxnSp>
          <p:nvCxnSpPr>
            <p:cNvPr id="14" name="Straight Arrow Connector 13">
              <a:extLst>
                <a:ext uri="{FF2B5EF4-FFF2-40B4-BE49-F238E27FC236}">
                  <a16:creationId xmlns:a16="http://schemas.microsoft.com/office/drawing/2014/main" id="{38274DA4-160C-68D1-0D9F-0CC217D4F3EB}"/>
                </a:ext>
              </a:extLst>
            </p:cNvPr>
            <p:cNvCxnSpPr>
              <a:cxnSpLocks/>
            </p:cNvCxnSpPr>
            <p:nvPr/>
          </p:nvCxnSpPr>
          <p:spPr>
            <a:xfrm>
              <a:off x="5162420" y="1951356"/>
              <a:ext cx="282592" cy="446156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077BE702-8895-9DE0-4338-57173739489A}"/>
                </a:ext>
              </a:extLst>
            </p:cNvPr>
            <p:cNvSpPr txBox="1"/>
            <p:nvPr/>
          </p:nvSpPr>
          <p:spPr>
            <a:xfrm>
              <a:off x="4787945" y="1717742"/>
              <a:ext cx="1528763" cy="2601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AU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UV Fibre</a:t>
              </a:r>
            </a:p>
          </p:txBody>
        </p:sp>
        <p:cxnSp>
          <p:nvCxnSpPr>
            <p:cNvPr id="17" name="Straight Arrow Connector 16">
              <a:extLst>
                <a:ext uri="{FF2B5EF4-FFF2-40B4-BE49-F238E27FC236}">
                  <a16:creationId xmlns:a16="http://schemas.microsoft.com/office/drawing/2014/main" id="{60360AEA-2544-797F-935F-3D6404D4BD8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101879" y="2698956"/>
              <a:ext cx="422986" cy="577362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6A92F922-8CBE-102E-96E3-66BAFB22A007}"/>
                </a:ext>
              </a:extLst>
            </p:cNvPr>
            <p:cNvSpPr txBox="1"/>
            <p:nvPr/>
          </p:nvSpPr>
          <p:spPr>
            <a:xfrm>
              <a:off x="2647540" y="3274647"/>
              <a:ext cx="1862138" cy="2601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AU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GW Port</a:t>
              </a:r>
            </a:p>
          </p:txBody>
        </p:sp>
        <p:cxnSp>
          <p:nvCxnSpPr>
            <p:cNvPr id="22" name="Straight Arrow Connector 21">
              <a:extLst>
                <a:ext uri="{FF2B5EF4-FFF2-40B4-BE49-F238E27FC236}">
                  <a16:creationId xmlns:a16="http://schemas.microsoft.com/office/drawing/2014/main" id="{E6B1C83D-4535-F2D7-773E-B652F8ACF500}"/>
                </a:ext>
              </a:extLst>
            </p:cNvPr>
            <p:cNvCxnSpPr>
              <a:cxnSpLocks/>
            </p:cNvCxnSpPr>
            <p:nvPr/>
          </p:nvCxnSpPr>
          <p:spPr>
            <a:xfrm>
              <a:off x="8055505" y="1749029"/>
              <a:ext cx="1110477" cy="202327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4179D980-AC51-3237-2840-6B67E46EA275}"/>
                </a:ext>
              </a:extLst>
            </p:cNvPr>
            <p:cNvSpPr txBox="1"/>
            <p:nvPr/>
          </p:nvSpPr>
          <p:spPr>
            <a:xfrm>
              <a:off x="6939314" y="1518196"/>
              <a:ext cx="2685120" cy="2601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AU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Distal Balloon Fibre Port </a:t>
              </a:r>
            </a:p>
          </p:txBody>
        </p:sp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2D332383-BB1A-FE4A-8C78-9325475D6068}"/>
              </a:ext>
            </a:extLst>
          </p:cNvPr>
          <p:cNvSpPr txBox="1"/>
          <p:nvPr/>
        </p:nvSpPr>
        <p:spPr>
          <a:xfrm>
            <a:off x="4124587" y="566063"/>
            <a:ext cx="39428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AU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Online Resource 2</a:t>
            </a:r>
          </a:p>
        </p:txBody>
      </p:sp>
    </p:spTree>
    <p:extLst>
      <p:ext uri="{BB962C8B-B14F-4D97-AF65-F5344CB8AC3E}">
        <p14:creationId xmlns:p14="http://schemas.microsoft.com/office/powerpoint/2010/main" val="8899656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</TotalTime>
  <Words>16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Monash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hony Dear</dc:creator>
  <cp:lastModifiedBy>Anthony Dear</cp:lastModifiedBy>
  <cp:revision>2</cp:revision>
  <dcterms:created xsi:type="dcterms:W3CDTF">2023-01-04T23:35:19Z</dcterms:created>
  <dcterms:modified xsi:type="dcterms:W3CDTF">2023-01-05T00:19:59Z</dcterms:modified>
</cp:coreProperties>
</file>